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Estilo medio 2 - Énfasis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4" d="100"/>
          <a:sy n="44" d="100"/>
        </p:scale>
        <p:origin x="40" y="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0896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4701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6802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78602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44288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75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145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170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7023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3949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4586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5981D5-8794-416C-8B2B-70ED7ED686E5}" type="datetimeFigureOut">
              <a:rPr lang="es-ES" smtClean="0"/>
              <a:t>04/07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1C7E7-D831-44A0-91E0-FE9140485DB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7321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519317"/>
              </p:ext>
            </p:extLst>
          </p:nvPr>
        </p:nvGraphicFramePr>
        <p:xfrm>
          <a:off x="1471294" y="877455"/>
          <a:ext cx="9186546" cy="379614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02946">
                  <a:extLst>
                    <a:ext uri="{9D8B030D-6E8A-4147-A177-3AD203B41FA5}">
                      <a16:colId xmlns:a16="http://schemas.microsoft.com/office/drawing/2014/main" val="4084559480"/>
                    </a:ext>
                  </a:extLst>
                </a:gridCol>
                <a:gridCol w="2844800">
                  <a:extLst>
                    <a:ext uri="{9D8B030D-6E8A-4147-A177-3AD203B41FA5}">
                      <a16:colId xmlns:a16="http://schemas.microsoft.com/office/drawing/2014/main" val="3073969076"/>
                    </a:ext>
                  </a:extLst>
                </a:gridCol>
                <a:gridCol w="2804160">
                  <a:extLst>
                    <a:ext uri="{9D8B030D-6E8A-4147-A177-3AD203B41FA5}">
                      <a16:colId xmlns:a16="http://schemas.microsoft.com/office/drawing/2014/main" val="2171872305"/>
                    </a:ext>
                  </a:extLst>
                </a:gridCol>
                <a:gridCol w="2834640">
                  <a:extLst>
                    <a:ext uri="{9D8B030D-6E8A-4147-A177-3AD203B41FA5}">
                      <a16:colId xmlns:a16="http://schemas.microsoft.com/office/drawing/2014/main" val="979486338"/>
                    </a:ext>
                  </a:extLst>
                </a:gridCol>
              </a:tblGrid>
              <a:tr h="374957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hsa-miR-10b-5p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hsa-miR-92a-3p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hsa-miR-155-5p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56554842"/>
                  </a:ext>
                </a:extLst>
              </a:tr>
              <a:tr h="744553">
                <a:tc>
                  <a:txBody>
                    <a:bodyPr/>
                    <a:lstStyle/>
                    <a:p>
                      <a:pPr marL="71755" marR="71755"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iRNA guide strand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UACCCUGUAGAACCGAAUUUGUG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UAUUGCACUUGUCCCGGCCUGU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UUAAUGCUAAUCGUGAUAGGGGUU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26590285"/>
                  </a:ext>
                </a:extLst>
              </a:tr>
              <a:tr h="689471">
                <a:tc>
                  <a:txBody>
                    <a:bodyPr/>
                    <a:lstStyle/>
                    <a:p>
                      <a:pPr marL="71755" marR="71755"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iRNA pass strand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CACAAAUUCGGUUCUACAGGGUAUUUUU/3ThioMC3-D</a:t>
                      </a:r>
                      <a:r>
                        <a:rPr lang="es-ES" sz="1100" dirty="0">
                          <a:effectLst/>
                        </a:rPr>
                        <a:t>/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ACAGGCCGGGACAAGUGCAAUAUUUUU/3ThioMC3-D</a:t>
                      </a:r>
                      <a:r>
                        <a:rPr lang="es-ES" sz="1100" dirty="0">
                          <a:effectLst/>
                        </a:rPr>
                        <a:t>/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AACCCCUAUCACGAUUAGCAUUAAUUUUU/3ThioMC3-D</a:t>
                      </a:r>
                      <a:r>
                        <a:rPr lang="es-ES" sz="1100" dirty="0">
                          <a:effectLst/>
                        </a:rPr>
                        <a:t>/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30972897"/>
                  </a:ext>
                </a:extLst>
              </a:tr>
              <a:tr h="374957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chemeClr val="bg1"/>
                          </a:solidFill>
                          <a:effectLst/>
                        </a:rPr>
                        <a:t>hsa-miR-124-5p</a:t>
                      </a:r>
                      <a:endParaRPr lang="es-ES" sz="12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chemeClr val="bg1"/>
                          </a:solidFill>
                          <a:effectLst/>
                        </a:rPr>
                        <a:t>hsa-miR-3607-3p</a:t>
                      </a:r>
                      <a:endParaRPr lang="es-ES" sz="12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chemeClr val="bg1"/>
                          </a:solidFill>
                          <a:effectLst/>
                        </a:rPr>
                        <a:t>hsa-miR-4518</a:t>
                      </a:r>
                      <a:endParaRPr lang="es-ES" sz="12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813286"/>
                  </a:ext>
                </a:extLst>
              </a:tr>
              <a:tr h="689471">
                <a:tc>
                  <a:txBody>
                    <a:bodyPr/>
                    <a:lstStyle/>
                    <a:p>
                      <a:pPr marL="71755" marR="71755"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iRNA guide strand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CGUGUUCACAGCGGACCUUGAU</a:t>
                      </a:r>
                      <a:endParaRPr lang="es-ES" sz="11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ACUGUAAACGCUUUCUGAUG</a:t>
                      </a:r>
                      <a:endParaRPr lang="es-ES" sz="11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GCUCAGGGAUGAUAACUGUGCUGAGA</a:t>
                      </a:r>
                      <a:endParaRPr lang="es-ES" sz="1100" dirty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03822965"/>
                  </a:ext>
                </a:extLst>
              </a:tr>
              <a:tr h="922736">
                <a:tc>
                  <a:txBody>
                    <a:bodyPr/>
                    <a:lstStyle/>
                    <a:p>
                      <a:pPr marL="71755" marR="71755"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miRNA pass strand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AUCAAGGUCCGCUGUGAACACG/3ThioMC3-D</a:t>
                      </a:r>
                      <a:r>
                        <a:rPr lang="es-ES" sz="11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CAUCAGAAAGCGUUUACAGU/3ThioMC3-D</a:t>
                      </a:r>
                      <a:r>
                        <a:rPr lang="es-ES" sz="11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effectLst/>
                        </a:rPr>
                        <a:t>UCUCAGCACAGUUAUCAUCCCUGAGC/3ThioMC3-D</a:t>
                      </a:r>
                      <a:r>
                        <a:rPr lang="es-ES" sz="1100" dirty="0">
                          <a:effectLst/>
                        </a:rPr>
                        <a:t>/</a:t>
                      </a: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</a:rPr>
                        <a:t>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703671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087144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44</Words>
  <Application>Microsoft Office PowerPoint</Application>
  <PresentationFormat>Panorámica</PresentationFormat>
  <Paragraphs>4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OLA MARIA FERNANDEZ MESSINA</dc:creator>
  <cp:lastModifiedBy>LOLA MARIA FERNANDEZ MESSINA</cp:lastModifiedBy>
  <cp:revision>3</cp:revision>
  <dcterms:created xsi:type="dcterms:W3CDTF">2022-06-29T13:33:01Z</dcterms:created>
  <dcterms:modified xsi:type="dcterms:W3CDTF">2022-07-04T09:03:10Z</dcterms:modified>
</cp:coreProperties>
</file>